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233C8-4A08-4935-8BA2-781B85E49FAA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A3DC-8196-4D1C-9212-C1BE65F4D6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434067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233C8-4A08-4935-8BA2-781B85E49FAA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A3DC-8196-4D1C-9212-C1BE65F4D6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129139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233C8-4A08-4935-8BA2-781B85E49FAA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A3DC-8196-4D1C-9212-C1BE65F4D6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217379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233C8-4A08-4935-8BA2-781B85E49FAA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A3DC-8196-4D1C-9212-C1BE65F4D6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61653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233C8-4A08-4935-8BA2-781B85E49FAA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A3DC-8196-4D1C-9212-C1BE65F4D6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250533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233C8-4A08-4935-8BA2-781B85E49FAA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A3DC-8196-4D1C-9212-C1BE65F4D6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78012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233C8-4A08-4935-8BA2-781B85E49FAA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A3DC-8196-4D1C-9212-C1BE65F4D6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30561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233C8-4A08-4935-8BA2-781B85E49FAA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A3DC-8196-4D1C-9212-C1BE65F4D6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5909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233C8-4A08-4935-8BA2-781B85E49FAA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A3DC-8196-4D1C-9212-C1BE65F4D6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39852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233C8-4A08-4935-8BA2-781B85E49FAA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A3DC-8196-4D1C-9212-C1BE65F4D6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44972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233C8-4A08-4935-8BA2-781B85E49FAA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A3DC-8196-4D1C-9212-C1BE65F4D6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827798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233C8-4A08-4935-8BA2-781B85E49FAA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39A3DC-8196-4D1C-9212-C1BE65F4D6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96347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1785" y="661987"/>
            <a:ext cx="7781925" cy="553402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593242" y="2900421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 Log (HOMA-S </a:t>
            </a:r>
            <a:r>
              <a:rPr lang="en-US" sz="2400" dirty="0"/>
              <a:t>Index)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5088835" y="5734347"/>
            <a:ext cx="2796208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</a:t>
            </a:r>
            <a:r>
              <a:rPr lang="en-US" sz="2400" dirty="0"/>
              <a:t>leptin</a:t>
            </a:r>
            <a:r>
              <a:rPr lang="es-CL" sz="2400" dirty="0"/>
              <a:t> (ng/ml))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7885043" y="1078679"/>
            <a:ext cx="16565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-0.44</a:t>
            </a:r>
          </a:p>
          <a:p>
            <a:r>
              <a:rPr lang="es-CL" dirty="0"/>
              <a:t>p= 0.0004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3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23151568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8850" y="647700"/>
            <a:ext cx="7734300" cy="55626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619747" y="3006439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Log (Matsuda  </a:t>
            </a:r>
            <a:r>
              <a:rPr lang="en-US" sz="2400" dirty="0"/>
              <a:t>Index)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5181600" y="5748635"/>
            <a:ext cx="2796208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</a:t>
            </a:r>
            <a:r>
              <a:rPr lang="en-US" sz="2400" dirty="0"/>
              <a:t>leptin</a:t>
            </a:r>
            <a:r>
              <a:rPr lang="es-CL" sz="2400" dirty="0"/>
              <a:t> (ng/ml))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7977808" y="967409"/>
            <a:ext cx="14577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-0.44</a:t>
            </a:r>
          </a:p>
          <a:p>
            <a:r>
              <a:rPr lang="es-CL" dirty="0"/>
              <a:t>p= 0.0005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3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21520386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5512" y="628650"/>
            <a:ext cx="7800975" cy="56007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627985" y="2661882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Log (CSi </a:t>
            </a:r>
            <a:r>
              <a:rPr lang="en-US" sz="2400" dirty="0"/>
              <a:t>Index)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5088835" y="5734347"/>
            <a:ext cx="2796208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</a:t>
            </a:r>
            <a:r>
              <a:rPr lang="en-US" sz="2400" dirty="0"/>
              <a:t>leptin</a:t>
            </a:r>
            <a:r>
              <a:rPr lang="es-CL" sz="2400" dirty="0"/>
              <a:t> (ng/ml))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7885043" y="1163306"/>
            <a:ext cx="12324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-0.26</a:t>
            </a:r>
          </a:p>
          <a:p>
            <a:r>
              <a:rPr lang="es-CL" dirty="0"/>
              <a:t>p= 0.0590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3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41862075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1816" y="657225"/>
            <a:ext cx="7820025" cy="554355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644222" y="3099063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 Log (HOMA-S </a:t>
            </a:r>
            <a:r>
              <a:rPr lang="en-US" sz="2400" dirty="0"/>
              <a:t>Index)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4505738" y="5739110"/>
            <a:ext cx="49039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</a:t>
            </a:r>
            <a:r>
              <a:rPr lang="en-US" sz="2400" dirty="0"/>
              <a:t>Total Adiponectin</a:t>
            </a:r>
            <a:r>
              <a:rPr lang="es-CL" sz="2400" dirty="0"/>
              <a:t> (µg/ml))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8520363" y="954157"/>
            <a:ext cx="13914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0.23</a:t>
            </a:r>
          </a:p>
          <a:p>
            <a:r>
              <a:rPr lang="es-CL" dirty="0"/>
              <a:t>p= 0.0723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3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18282959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0750" y="628650"/>
            <a:ext cx="7810500" cy="56007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692175" y="3165323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Log (Matsuda  </a:t>
            </a:r>
            <a:r>
              <a:rPr lang="en-US" sz="2400" dirty="0"/>
              <a:t>Index)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4505738" y="5739110"/>
            <a:ext cx="49039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</a:t>
            </a:r>
            <a:r>
              <a:rPr lang="en-US" sz="2400" dirty="0"/>
              <a:t>Total Adiponectin</a:t>
            </a:r>
            <a:r>
              <a:rPr lang="es-CL" sz="2400" dirty="0"/>
              <a:t> (µg/ml))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8587409" y="1020417"/>
            <a:ext cx="13119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0.33</a:t>
            </a:r>
          </a:p>
          <a:p>
            <a:r>
              <a:rPr lang="es-CL" dirty="0"/>
              <a:t>p= 0.0097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3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33557908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5512" y="661987"/>
            <a:ext cx="7800975" cy="553402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627985" y="2661882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Log CSi </a:t>
            </a:r>
            <a:r>
              <a:rPr lang="en-US" sz="2400" dirty="0"/>
              <a:t>Index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4505738" y="5739110"/>
            <a:ext cx="49039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</a:t>
            </a:r>
            <a:r>
              <a:rPr lang="en-US" sz="2400" dirty="0"/>
              <a:t>Total Adiponectin</a:t>
            </a:r>
            <a:r>
              <a:rPr lang="es-CL" sz="2400" dirty="0"/>
              <a:t> (µg/ml))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8627165" y="840140"/>
            <a:ext cx="13693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0.32</a:t>
            </a:r>
          </a:p>
          <a:p>
            <a:r>
              <a:rPr lang="es-CL" dirty="0"/>
              <a:t>P= 0.0219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3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29228320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666750"/>
            <a:ext cx="7772400" cy="55245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593242" y="2900421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 Log (HOMA-S </a:t>
            </a:r>
            <a:r>
              <a:rPr lang="en-US" sz="2400" dirty="0"/>
              <a:t>Index)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5018414" y="5729585"/>
            <a:ext cx="46307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HMWA (µg/ml))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8017565" y="1078679"/>
            <a:ext cx="13782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0.14</a:t>
            </a:r>
          </a:p>
          <a:p>
            <a:r>
              <a:rPr lang="es-CL" dirty="0"/>
              <a:t>p= 0.2735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3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37367116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5512" y="666750"/>
            <a:ext cx="7800975" cy="55245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606494" y="2900422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Log (Matsuda  </a:t>
            </a:r>
            <a:r>
              <a:rPr lang="en-US" sz="2400" dirty="0"/>
              <a:t>Index)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5217197" y="5729585"/>
            <a:ext cx="46307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HMWA (µg/ml))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7938052" y="887895"/>
            <a:ext cx="13384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0.17</a:t>
            </a:r>
          </a:p>
          <a:p>
            <a:r>
              <a:rPr lang="es-CL" dirty="0"/>
              <a:t>p= 0.1837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3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15472675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6559" y="619125"/>
            <a:ext cx="7829550" cy="561975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627985" y="2661882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Log (CSi </a:t>
            </a:r>
            <a:r>
              <a:rPr lang="en-US" sz="2400" dirty="0"/>
              <a:t>Index)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5005163" y="5777210"/>
            <a:ext cx="46307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HMWA (µg/ml))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7977808" y="954156"/>
            <a:ext cx="13252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0.12</a:t>
            </a:r>
          </a:p>
          <a:p>
            <a:r>
              <a:rPr lang="es-CL" dirty="0"/>
              <a:t>p= 0.3995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3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37842719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2</Words>
  <Application>Microsoft Office PowerPoint</Application>
  <PresentationFormat>Panorámica</PresentationFormat>
  <Paragraphs>45</Paragraphs>
  <Slides>9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ito Bravo</dc:creator>
  <cp:lastModifiedBy>Carito Bravo</cp:lastModifiedBy>
  <cp:revision>1</cp:revision>
  <dcterms:created xsi:type="dcterms:W3CDTF">2017-03-27T14:47:17Z</dcterms:created>
  <dcterms:modified xsi:type="dcterms:W3CDTF">2017-03-27T14:47:32Z</dcterms:modified>
</cp:coreProperties>
</file>